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70" r:id="rId2"/>
    <p:sldId id="261" r:id="rId3"/>
    <p:sldId id="264" r:id="rId4"/>
    <p:sldId id="271" r:id="rId5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502"/>
    <p:restoredTop sz="96000"/>
  </p:normalViewPr>
  <p:slideViewPr>
    <p:cSldViewPr snapToGrid="0" snapToObjects="1">
      <p:cViewPr varScale="1">
        <p:scale>
          <a:sx n="74" d="100"/>
          <a:sy n="74" d="100"/>
        </p:scale>
        <p:origin x="84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380423B1-1F1E-7E4E-8AFB-F4BA3437302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="" xmlns:a16="http://schemas.microsoft.com/office/drawing/2014/main" id="{C4154B73-C153-4B4C-8FC9-57D1636885A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="" xmlns:a16="http://schemas.microsoft.com/office/drawing/2014/main" id="{2DD1034F-FF8F-F341-8830-E107FFEFD3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FA2750-B189-084E-A523-3F64A7E192F7}" type="datetimeFigureOut">
              <a:rPr kumimoji="1" lang="ja-JP" altLang="en-US" smtClean="0"/>
              <a:t>2021/2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="" xmlns:a16="http://schemas.microsoft.com/office/drawing/2014/main" id="{3299D04E-8078-A04A-BF20-1E2DE64ADC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="" xmlns:a16="http://schemas.microsoft.com/office/drawing/2014/main" id="{E7D86EDA-A715-0743-BF23-5B0B621456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55933-CD26-BE43-867D-7D8F856A25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69240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1C6F8122-B9B7-F441-862D-B03AFFD93B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="" xmlns:a16="http://schemas.microsoft.com/office/drawing/2014/main" id="{207809ED-1154-A14E-8AF3-4152E667295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="" xmlns:a16="http://schemas.microsoft.com/office/drawing/2014/main" id="{549DA73C-3503-7640-9014-108AE7125A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FA2750-B189-084E-A523-3F64A7E192F7}" type="datetimeFigureOut">
              <a:rPr kumimoji="1" lang="ja-JP" altLang="en-US" smtClean="0"/>
              <a:t>2021/2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="" xmlns:a16="http://schemas.microsoft.com/office/drawing/2014/main" id="{BD92146D-197C-9440-B42E-ADEBF43CD6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="" xmlns:a16="http://schemas.microsoft.com/office/drawing/2014/main" id="{7BF236A0-44D6-2243-A6EE-E17FEB25DE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55933-CD26-BE43-867D-7D8F856A25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96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="" xmlns:a16="http://schemas.microsoft.com/office/drawing/2014/main" id="{9FD17B6C-910F-294B-A03D-CCE1E90928B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="" xmlns:a16="http://schemas.microsoft.com/office/drawing/2014/main" id="{298D2605-CDC9-EC43-BE78-1E094358FFB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="" xmlns:a16="http://schemas.microsoft.com/office/drawing/2014/main" id="{7A6FF3E0-01ED-6C46-BD9A-E5F8CCDCDA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FA2750-B189-084E-A523-3F64A7E192F7}" type="datetimeFigureOut">
              <a:rPr kumimoji="1" lang="ja-JP" altLang="en-US" smtClean="0"/>
              <a:t>2021/2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="" xmlns:a16="http://schemas.microsoft.com/office/drawing/2014/main" id="{952F2D49-D6A6-9544-81AA-85E8238659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="" xmlns:a16="http://schemas.microsoft.com/office/drawing/2014/main" id="{7DCC31CC-B481-9C49-8BEF-AC05870BC5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55933-CD26-BE43-867D-7D8F856A25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99743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3C19DBDE-9E9E-3848-A743-C2BBBABE17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="" xmlns:a16="http://schemas.microsoft.com/office/drawing/2014/main" id="{CA1FE628-19CC-9A44-9B8E-C999E0D3821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="" xmlns:a16="http://schemas.microsoft.com/office/drawing/2014/main" id="{CDAFB2CE-1EAB-8A4B-8D28-4D72CD7B02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FA2750-B189-084E-A523-3F64A7E192F7}" type="datetimeFigureOut">
              <a:rPr kumimoji="1" lang="ja-JP" altLang="en-US" smtClean="0"/>
              <a:t>2021/2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="" xmlns:a16="http://schemas.microsoft.com/office/drawing/2014/main" id="{642D2022-A095-8F41-B504-315D5CD2DE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="" xmlns:a16="http://schemas.microsoft.com/office/drawing/2014/main" id="{9E79CBD2-723B-9840-8BED-696DDDF35A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55933-CD26-BE43-867D-7D8F856A25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86167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EB8448F5-5829-C343-8596-CB8C9029AA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="" xmlns:a16="http://schemas.microsoft.com/office/drawing/2014/main" id="{C5CDF543-02ED-7846-8A1F-4B474B3CC7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="" xmlns:a16="http://schemas.microsoft.com/office/drawing/2014/main" id="{4FC54196-360C-F541-93D1-ADA361C0D5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FA2750-B189-084E-A523-3F64A7E192F7}" type="datetimeFigureOut">
              <a:rPr kumimoji="1" lang="ja-JP" altLang="en-US" smtClean="0"/>
              <a:t>2021/2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="" xmlns:a16="http://schemas.microsoft.com/office/drawing/2014/main" id="{BF87641F-9C44-DA4F-8997-F41D27E770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="" xmlns:a16="http://schemas.microsoft.com/office/drawing/2014/main" id="{B41AFB1A-CB2A-694D-B197-7464CC220C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55933-CD26-BE43-867D-7D8F856A25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78787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74F5DF08-4352-434E-B5A1-A94093F36A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="" xmlns:a16="http://schemas.microsoft.com/office/drawing/2014/main" id="{F668C24C-C2EB-B743-920C-3C6139CAB3E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="" xmlns:a16="http://schemas.microsoft.com/office/drawing/2014/main" id="{2FF5E80C-9E0C-0247-9C92-A5279B9F5A5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="" xmlns:a16="http://schemas.microsoft.com/office/drawing/2014/main" id="{6BBB4F2D-7C41-1045-B46B-8F47CF5EAE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FA2750-B189-084E-A523-3F64A7E192F7}" type="datetimeFigureOut">
              <a:rPr kumimoji="1" lang="ja-JP" altLang="en-US" smtClean="0"/>
              <a:t>2021/2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="" xmlns:a16="http://schemas.microsoft.com/office/drawing/2014/main" id="{889D1123-6DA0-054B-B6B0-2C36195D03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="" xmlns:a16="http://schemas.microsoft.com/office/drawing/2014/main" id="{D76C84EC-ED5B-F24C-B17F-3A12DC7B1B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55933-CD26-BE43-867D-7D8F856A25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07771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44C720E7-41EA-4847-A1D4-7D6DCAA6A3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="" xmlns:a16="http://schemas.microsoft.com/office/drawing/2014/main" id="{9E448283-E153-BF4E-8FFF-3FE851CD097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="" xmlns:a16="http://schemas.microsoft.com/office/drawing/2014/main" id="{2106E74B-18AB-874B-85A4-B65FF6F59AA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="" xmlns:a16="http://schemas.microsoft.com/office/drawing/2014/main" id="{ED29A536-0DE4-9447-89F3-AEB1C0779E0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="" xmlns:a16="http://schemas.microsoft.com/office/drawing/2014/main" id="{DD377B3C-3006-FC48-AB47-2AFB127991D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="" xmlns:a16="http://schemas.microsoft.com/office/drawing/2014/main" id="{1F15A670-3EBC-004C-AC8F-FCF571F16A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FA2750-B189-084E-A523-3F64A7E192F7}" type="datetimeFigureOut">
              <a:rPr kumimoji="1" lang="ja-JP" altLang="en-US" smtClean="0"/>
              <a:t>2021/2/27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="" xmlns:a16="http://schemas.microsoft.com/office/drawing/2014/main" id="{85B4C28E-5D00-A147-8FA0-0CC8C259C2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="" xmlns:a16="http://schemas.microsoft.com/office/drawing/2014/main" id="{9AA5A205-3471-CE4F-A016-3651A4A37B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55933-CD26-BE43-867D-7D8F856A25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52068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35F9BA81-D947-DC44-AEA2-B3D3B4A9A6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="" xmlns:a16="http://schemas.microsoft.com/office/drawing/2014/main" id="{934CA632-FD19-F84A-B2C9-A687168C67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FA2750-B189-084E-A523-3F64A7E192F7}" type="datetimeFigureOut">
              <a:rPr kumimoji="1" lang="ja-JP" altLang="en-US" smtClean="0"/>
              <a:t>2021/2/27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="" xmlns:a16="http://schemas.microsoft.com/office/drawing/2014/main" id="{40302266-30A9-9C46-9078-51531EF5FA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="" xmlns:a16="http://schemas.microsoft.com/office/drawing/2014/main" id="{D46CF1BC-DFCD-4D47-BC73-C374CAA7AC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55933-CD26-BE43-867D-7D8F856A25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39914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="" xmlns:a16="http://schemas.microsoft.com/office/drawing/2014/main" id="{F5B41406-5A9C-1C4D-8E9C-A250867176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FA2750-B189-084E-A523-3F64A7E192F7}" type="datetimeFigureOut">
              <a:rPr kumimoji="1" lang="ja-JP" altLang="en-US" smtClean="0"/>
              <a:t>2021/2/27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="" xmlns:a16="http://schemas.microsoft.com/office/drawing/2014/main" id="{FE3A329E-5FFD-B74F-8B94-8281F6A381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="" xmlns:a16="http://schemas.microsoft.com/office/drawing/2014/main" id="{9DC0F76E-C325-3742-A2DC-31E9C91768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55933-CD26-BE43-867D-7D8F856A25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70120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CBBBCF8B-6D28-BA4F-B8E3-461EF3AED9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="" xmlns:a16="http://schemas.microsoft.com/office/drawing/2014/main" id="{63055838-AE69-1745-9092-750130061F3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="" xmlns:a16="http://schemas.microsoft.com/office/drawing/2014/main" id="{962B0D43-447E-D74B-8F15-D4A3B48CD07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="" xmlns:a16="http://schemas.microsoft.com/office/drawing/2014/main" id="{5E23985D-237B-FE44-ACD1-42C7E7F2B3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FA2750-B189-084E-A523-3F64A7E192F7}" type="datetimeFigureOut">
              <a:rPr kumimoji="1" lang="ja-JP" altLang="en-US" smtClean="0"/>
              <a:t>2021/2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="" xmlns:a16="http://schemas.microsoft.com/office/drawing/2014/main" id="{54AD6D95-0844-B64D-95E6-6FFFF026A0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="" xmlns:a16="http://schemas.microsoft.com/office/drawing/2014/main" id="{371913B3-F6C9-B74A-993F-4391E9FCE2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55933-CD26-BE43-867D-7D8F856A25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24205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752D6FDA-7309-BD4D-A493-AB659E718F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="" xmlns:a16="http://schemas.microsoft.com/office/drawing/2014/main" id="{4E3DDB75-BC85-2746-81DE-20CB8CF2FCE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="" xmlns:a16="http://schemas.microsoft.com/office/drawing/2014/main" id="{5563178B-4031-2647-9897-3F5EE81D861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="" xmlns:a16="http://schemas.microsoft.com/office/drawing/2014/main" id="{7EEACEA6-E2E6-CE44-A20D-F3998010DB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FA2750-B189-084E-A523-3F64A7E192F7}" type="datetimeFigureOut">
              <a:rPr kumimoji="1" lang="ja-JP" altLang="en-US" smtClean="0"/>
              <a:t>2021/2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="" xmlns:a16="http://schemas.microsoft.com/office/drawing/2014/main" id="{08B62ED0-E50B-164E-A167-EBBDA7709D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="" xmlns:a16="http://schemas.microsoft.com/office/drawing/2014/main" id="{50234E60-E0EB-7B4B-900C-81B0A43692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55933-CD26-BE43-867D-7D8F856A25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65369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="" xmlns:a16="http://schemas.microsoft.com/office/drawing/2014/main" id="{1F2C375C-ED2C-AF42-AD4D-0E92465D3D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="" xmlns:a16="http://schemas.microsoft.com/office/drawing/2014/main" id="{2B60EE0D-E5ED-3845-9C3B-DF158968A4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="" xmlns:a16="http://schemas.microsoft.com/office/drawing/2014/main" id="{F9AB27EB-443C-AA45-841C-BA087DDC721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FA2750-B189-084E-A523-3F64A7E192F7}" type="datetimeFigureOut">
              <a:rPr kumimoji="1" lang="ja-JP" altLang="en-US" smtClean="0"/>
              <a:t>2021/2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="" xmlns:a16="http://schemas.microsoft.com/office/drawing/2014/main" id="{81982398-DD94-1C4E-B703-E4D6DDB248B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="" xmlns:a16="http://schemas.microsoft.com/office/drawing/2014/main" id="{0E651FDC-AC1C-1943-917A-E6D56E749DF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455933-CD26-BE43-867D-7D8F856A25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59536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="" xmlns:a16="http://schemas.microsoft.com/office/drawing/2014/main" id="{916732E3-1AAF-374B-9292-9569AF85D52D}"/>
              </a:ext>
            </a:extLst>
          </p:cNvPr>
          <p:cNvSpPr txBox="1"/>
          <p:nvPr/>
        </p:nvSpPr>
        <p:spPr>
          <a:xfrm>
            <a:off x="0" y="6015209"/>
            <a:ext cx="28440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materials</a:t>
            </a:r>
          </a:p>
        </p:txBody>
      </p:sp>
      <p:sp>
        <p:nvSpPr>
          <p:cNvPr id="5" name="テキスト ボックス 4">
            <a:extLst>
              <a:ext uri="{FF2B5EF4-FFF2-40B4-BE49-F238E27FC236}">
                <a16:creationId xmlns="" xmlns:a16="http://schemas.microsoft.com/office/drawing/2014/main" id="{2172BE07-6C61-034F-A94C-F741DF41B63B}"/>
              </a:ext>
            </a:extLst>
          </p:cNvPr>
          <p:cNvSpPr txBox="1"/>
          <p:nvPr/>
        </p:nvSpPr>
        <p:spPr>
          <a:xfrm>
            <a:off x="0" y="6488668"/>
            <a:ext cx="68531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l Figure 1. Snap shots of simulation with tall patients</a:t>
            </a: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45906" y="0"/>
            <a:ext cx="4693363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801057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" name="図 2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71968" y="1037051"/>
            <a:ext cx="9625286" cy="4783897"/>
          </a:xfrm>
          <a:prstGeom prst="rect">
            <a:avLst/>
          </a:prstGeom>
        </p:spPr>
      </p:pic>
      <p:sp>
        <p:nvSpPr>
          <p:cNvPr id="2" name="正方形/長方形 1">
            <a:extLst>
              <a:ext uri="{FF2B5EF4-FFF2-40B4-BE49-F238E27FC236}">
                <a16:creationId xmlns="" xmlns:a16="http://schemas.microsoft.com/office/drawing/2014/main" id="{F765C9AF-153E-C847-A0A2-4635CCEAB763}"/>
              </a:ext>
            </a:extLst>
          </p:cNvPr>
          <p:cNvSpPr/>
          <p:nvPr/>
        </p:nvSpPr>
        <p:spPr>
          <a:xfrm>
            <a:off x="1483604" y="6211669"/>
            <a:ext cx="9802015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. Emission distribution of indoor mist aerosol verification experiment</a:t>
            </a:r>
            <a:endParaRPr lang="en-US" altLang="ja-JP" dirty="0"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0988405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 descr="グラフィカル ユーザー インターフェイス&#10;&#10;中程度の精度で自動的に生成された説明">
            <a:extLst>
              <a:ext uri="{FF2B5EF4-FFF2-40B4-BE49-F238E27FC236}">
                <a16:creationId xmlns="" xmlns:a16="http://schemas.microsoft.com/office/drawing/2014/main" id="{03508AEA-9249-9242-B568-EC8211626B9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6739" y="1335881"/>
            <a:ext cx="10878521" cy="4186237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="" xmlns:a16="http://schemas.microsoft.com/office/drawing/2014/main" id="{259E34DB-B61C-3044-A9AB-89AC825F6C51}"/>
              </a:ext>
            </a:extLst>
          </p:cNvPr>
          <p:cNvSpPr txBox="1"/>
          <p:nvPr/>
        </p:nvSpPr>
        <p:spPr>
          <a:xfrm>
            <a:off x="231354" y="6310820"/>
            <a:ext cx="119606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 Verification of mist aerosol in the room without surgical mask (1) and with surgical mask (2)</a:t>
            </a:r>
          </a:p>
        </p:txBody>
      </p:sp>
    </p:spTree>
    <p:extLst>
      <p:ext uri="{BB962C8B-B14F-4D97-AF65-F5344CB8AC3E}">
        <p14:creationId xmlns:p14="http://schemas.microsoft.com/office/powerpoint/2010/main" val="175460841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table" descr="黒い背景と白い文字&#10;&#10;自動的に生成された説明">
            <a:extLst>
              <a:ext uri="{FF2B5EF4-FFF2-40B4-BE49-F238E27FC236}">
                <a16:creationId xmlns="" xmlns:a16="http://schemas.microsoft.com/office/drawing/2014/main" id="{12AF4FA8-D918-E24D-BA39-2166802D438C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5214420" y="998989"/>
            <a:ext cx="5060950" cy="984885"/>
          </a:xfrm>
          <a:prstGeom prst="rect">
            <a:avLst/>
          </a:prstGeom>
        </p:spPr>
      </p:pic>
      <p:pic>
        <p:nvPicPr>
          <p:cNvPr id="3" name="table" descr="黒い背景と白い文字&#10;&#10;自動的に生成された説明">
            <a:extLst>
              <a:ext uri="{FF2B5EF4-FFF2-40B4-BE49-F238E27FC236}">
                <a16:creationId xmlns="" xmlns:a16="http://schemas.microsoft.com/office/drawing/2014/main" id="{77B03647-8461-AF48-8FB8-E5A40A712B26}"/>
              </a:ext>
            </a:extLst>
          </p:cNvPr>
          <p:cNvPicPr/>
          <p:nvPr/>
        </p:nvPicPr>
        <p:blipFill>
          <a:blip r:embed="rId3"/>
          <a:stretch>
            <a:fillRect/>
          </a:stretch>
        </p:blipFill>
        <p:spPr>
          <a:xfrm>
            <a:off x="5214420" y="1913389"/>
            <a:ext cx="5060950" cy="984885"/>
          </a:xfrm>
          <a:prstGeom prst="rect">
            <a:avLst/>
          </a:prstGeom>
        </p:spPr>
      </p:pic>
      <p:pic>
        <p:nvPicPr>
          <p:cNvPr id="4" name="table" descr="黒い背景と白い文字&#10;&#10;自動的に生成された説明">
            <a:extLst>
              <a:ext uri="{FF2B5EF4-FFF2-40B4-BE49-F238E27FC236}">
                <a16:creationId xmlns="" xmlns:a16="http://schemas.microsoft.com/office/drawing/2014/main" id="{958D8D5B-7D78-404A-99CC-976CE628B989}"/>
              </a:ext>
            </a:extLst>
          </p:cNvPr>
          <p:cNvPicPr/>
          <p:nvPr/>
        </p:nvPicPr>
        <p:blipFill>
          <a:blip r:embed="rId4"/>
          <a:stretch>
            <a:fillRect/>
          </a:stretch>
        </p:blipFill>
        <p:spPr>
          <a:xfrm>
            <a:off x="5214420" y="2977014"/>
            <a:ext cx="5060950" cy="984885"/>
          </a:xfrm>
          <a:prstGeom prst="rect">
            <a:avLst/>
          </a:prstGeom>
        </p:spPr>
      </p:pic>
      <p:pic>
        <p:nvPicPr>
          <p:cNvPr id="5" name="table" descr="黒い背景と白い文字&#10;&#10;自動的に生成された説明">
            <a:extLst>
              <a:ext uri="{FF2B5EF4-FFF2-40B4-BE49-F238E27FC236}">
                <a16:creationId xmlns="" xmlns:a16="http://schemas.microsoft.com/office/drawing/2014/main" id="{6367569C-FAB3-154F-84CB-99212A1FA57E}"/>
              </a:ext>
            </a:extLst>
          </p:cNvPr>
          <p:cNvPicPr/>
          <p:nvPr/>
        </p:nvPicPr>
        <p:blipFill>
          <a:blip r:embed="rId5"/>
          <a:stretch>
            <a:fillRect/>
          </a:stretch>
        </p:blipFill>
        <p:spPr>
          <a:xfrm>
            <a:off x="5214420" y="3965709"/>
            <a:ext cx="5060950" cy="984885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="" xmlns:a16="http://schemas.microsoft.com/office/drawing/2014/main" id="{A300FE1D-7B1B-DC47-8DF9-A56302C82375}"/>
              </a:ext>
            </a:extLst>
          </p:cNvPr>
          <p:cNvSpPr txBox="1"/>
          <p:nvPr/>
        </p:nvSpPr>
        <p:spPr>
          <a:xfrm>
            <a:off x="1700011" y="5859011"/>
            <a:ext cx="87085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Table 1. Particle emission rate with/without air blow with tall patients</a:t>
            </a:r>
          </a:p>
        </p:txBody>
      </p:sp>
    </p:spTree>
    <p:extLst>
      <p:ext uri="{BB962C8B-B14F-4D97-AF65-F5344CB8AC3E}">
        <p14:creationId xmlns:p14="http://schemas.microsoft.com/office/powerpoint/2010/main" val="14164894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588</TotalTime>
  <Words>61</Words>
  <Application>Microsoft Office PowerPoint</Application>
  <PresentationFormat>Widescreen</PresentationFormat>
  <Paragraphs>5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游ゴシック</vt:lpstr>
      <vt:lpstr>游ゴシック Light</vt:lpstr>
      <vt:lpstr>Arial</vt:lpstr>
      <vt:lpstr>Office テーマ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髙田 護</dc:creator>
  <cp:lastModifiedBy>Pon Abirami A.</cp:lastModifiedBy>
  <cp:revision>18</cp:revision>
  <dcterms:created xsi:type="dcterms:W3CDTF">2021-01-16T01:23:36Z</dcterms:created>
  <dcterms:modified xsi:type="dcterms:W3CDTF">2021-02-27T05:54:08Z</dcterms:modified>
</cp:coreProperties>
</file>